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305" r:id="rId2"/>
  </p:sldIdLst>
  <p:sldSz cx="6858000" cy="9906000" type="A4"/>
  <p:notesSz cx="6799263" cy="99298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7E77"/>
    <a:srgbClr val="FF8AD8"/>
    <a:srgbClr val="F2F2F2"/>
    <a:srgbClr val="FAFAFA"/>
    <a:srgbClr val="5C665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Aucun style, aucune grille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Aucun style, grille du tableau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D7B26C5-4107-4FEC-AEDC-1716B250A1EF}" styleName="Style clair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F2DE63D5-997A-4646-A377-4702673A728D}" styleName="Style léger 2 - Accentuation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7E9639D4-E3E2-4D34-9284-5A2195B3D0D7}" styleName="Style clair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387" autoAdjust="0"/>
    <p:restoredTop sz="94277"/>
  </p:normalViewPr>
  <p:slideViewPr>
    <p:cSldViewPr snapToGrid="0">
      <p:cViewPr varScale="1">
        <p:scale>
          <a:sx n="75" d="100"/>
          <a:sy n="75" d="100"/>
        </p:scale>
        <p:origin x="3120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51275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27E9E69-94B8-6846-8831-8FFB33FB9D64}" type="datetimeFigureOut">
              <a:rPr lang="fr-FR" smtClean="0"/>
              <a:t>24/10/2023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9337" cy="33512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79450" y="4778375"/>
            <a:ext cx="5440363" cy="391001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431338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51275" y="9431338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42FD0DA-937E-B24B-9D15-1C64ED810B6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684773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4808C-BCD8-4184-8275-C74A81F64D98}" type="datetimeFigureOut">
              <a:rPr lang="en-US" smtClean="0"/>
              <a:t>10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E8A1C-422E-48F1-A80E-0ECBD71154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88715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4808C-BCD8-4184-8275-C74A81F64D98}" type="datetimeFigureOut">
              <a:rPr lang="en-US" smtClean="0"/>
              <a:t>10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E8A1C-422E-48F1-A80E-0ECBD71154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89037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4808C-BCD8-4184-8275-C74A81F64D98}" type="datetimeFigureOut">
              <a:rPr lang="en-US" smtClean="0"/>
              <a:t>10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E8A1C-422E-48F1-A80E-0ECBD71154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77827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4808C-BCD8-4184-8275-C74A81F64D98}" type="datetimeFigureOut">
              <a:rPr lang="en-US" smtClean="0"/>
              <a:t>10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E8A1C-422E-48F1-A80E-0ECBD71154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78332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4808C-BCD8-4184-8275-C74A81F64D98}" type="datetimeFigureOut">
              <a:rPr lang="en-US" smtClean="0"/>
              <a:t>10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E8A1C-422E-48F1-A80E-0ECBD71154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31959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4808C-BCD8-4184-8275-C74A81F64D98}" type="datetimeFigureOut">
              <a:rPr lang="en-US" smtClean="0"/>
              <a:t>10/24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E8A1C-422E-48F1-A80E-0ECBD71154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48425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4808C-BCD8-4184-8275-C74A81F64D98}" type="datetimeFigureOut">
              <a:rPr lang="en-US" smtClean="0"/>
              <a:t>10/24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E8A1C-422E-48F1-A80E-0ECBD71154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36873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4808C-BCD8-4184-8275-C74A81F64D98}" type="datetimeFigureOut">
              <a:rPr lang="en-US" smtClean="0"/>
              <a:t>10/24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E8A1C-422E-48F1-A80E-0ECBD71154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32584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4808C-BCD8-4184-8275-C74A81F64D98}" type="datetimeFigureOut">
              <a:rPr lang="en-US" smtClean="0"/>
              <a:t>10/24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E8A1C-422E-48F1-A80E-0ECBD71154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71590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4808C-BCD8-4184-8275-C74A81F64D98}" type="datetimeFigureOut">
              <a:rPr lang="en-US" smtClean="0"/>
              <a:t>10/24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E8A1C-422E-48F1-A80E-0ECBD71154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48672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4808C-BCD8-4184-8275-C74A81F64D98}" type="datetimeFigureOut">
              <a:rPr lang="en-US" smtClean="0"/>
              <a:t>10/24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E8A1C-422E-48F1-A80E-0ECBD71154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37054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44808C-BCD8-4184-8275-C74A81F64D98}" type="datetimeFigureOut">
              <a:rPr lang="en-US" smtClean="0"/>
              <a:t>10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BE8A1C-422E-48F1-A80E-0ECBD71154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03650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168E62B9-23EB-8DB8-5B96-BE08E19DFF8D}"/>
              </a:ext>
            </a:extLst>
          </p:cNvPr>
          <p:cNvGraphicFramePr>
            <a:graphicFrameLocks noGrp="1"/>
          </p:cNvGraphicFramePr>
          <p:nvPr/>
        </p:nvGraphicFramePr>
        <p:xfrm>
          <a:off x="119496" y="2071933"/>
          <a:ext cx="6619008" cy="3450114"/>
        </p:xfrm>
        <a:graphic>
          <a:graphicData uri="http://schemas.openxmlformats.org/drawingml/2006/table">
            <a:tbl>
              <a:tblPr/>
              <a:tblGrid>
                <a:gridCol w="2378053">
                  <a:extLst>
                    <a:ext uri="{9D8B030D-6E8A-4147-A177-3AD203B41FA5}">
                      <a16:colId xmlns:a16="http://schemas.microsoft.com/office/drawing/2014/main" val="2673875646"/>
                    </a:ext>
                  </a:extLst>
                </a:gridCol>
                <a:gridCol w="530099">
                  <a:extLst>
                    <a:ext uri="{9D8B030D-6E8A-4147-A177-3AD203B41FA5}">
                      <a16:colId xmlns:a16="http://schemas.microsoft.com/office/drawing/2014/main" val="1939727764"/>
                    </a:ext>
                  </a:extLst>
                </a:gridCol>
                <a:gridCol w="530262">
                  <a:extLst>
                    <a:ext uri="{9D8B030D-6E8A-4147-A177-3AD203B41FA5}">
                      <a16:colId xmlns:a16="http://schemas.microsoft.com/office/drawing/2014/main" val="236705553"/>
                    </a:ext>
                  </a:extLst>
                </a:gridCol>
                <a:gridCol w="530099">
                  <a:extLst>
                    <a:ext uri="{9D8B030D-6E8A-4147-A177-3AD203B41FA5}">
                      <a16:colId xmlns:a16="http://schemas.microsoft.com/office/drawing/2014/main" val="2576690917"/>
                    </a:ext>
                  </a:extLst>
                </a:gridCol>
                <a:gridCol w="530099">
                  <a:extLst>
                    <a:ext uri="{9D8B030D-6E8A-4147-A177-3AD203B41FA5}">
                      <a16:colId xmlns:a16="http://schemas.microsoft.com/office/drawing/2014/main" val="595067552"/>
                    </a:ext>
                  </a:extLst>
                </a:gridCol>
                <a:gridCol w="530099">
                  <a:extLst>
                    <a:ext uri="{9D8B030D-6E8A-4147-A177-3AD203B41FA5}">
                      <a16:colId xmlns:a16="http://schemas.microsoft.com/office/drawing/2014/main" val="927614547"/>
                    </a:ext>
                  </a:extLst>
                </a:gridCol>
                <a:gridCol w="530099">
                  <a:extLst>
                    <a:ext uri="{9D8B030D-6E8A-4147-A177-3AD203B41FA5}">
                      <a16:colId xmlns:a16="http://schemas.microsoft.com/office/drawing/2014/main" val="3562709634"/>
                    </a:ext>
                  </a:extLst>
                </a:gridCol>
                <a:gridCol w="530099">
                  <a:extLst>
                    <a:ext uri="{9D8B030D-6E8A-4147-A177-3AD203B41FA5}">
                      <a16:colId xmlns:a16="http://schemas.microsoft.com/office/drawing/2014/main" val="3280491328"/>
                    </a:ext>
                  </a:extLst>
                </a:gridCol>
                <a:gridCol w="530099">
                  <a:extLst>
                    <a:ext uri="{9D8B030D-6E8A-4147-A177-3AD203B41FA5}">
                      <a16:colId xmlns:a16="http://schemas.microsoft.com/office/drawing/2014/main" val="2943630556"/>
                    </a:ext>
                  </a:extLst>
                </a:gridCol>
              </a:tblGrid>
              <a:tr h="127782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rains</a:t>
                      </a:r>
                    </a:p>
                  </a:txBody>
                  <a:tcPr marL="5545" marR="5545" marT="554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_PB2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_PB1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_PA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_HA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_NP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_NA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_MP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_NS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81209578"/>
                  </a:ext>
                </a:extLst>
              </a:tr>
              <a:tr h="127782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/equine/Miami/1/1963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028843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028842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028841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028836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028839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06580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028837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028840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11105962"/>
                  </a:ext>
                </a:extLst>
              </a:tr>
              <a:tr h="127782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/equine/Uruguay/1/1963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032428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032427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032426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032421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032424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032423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032422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032425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68921315"/>
                  </a:ext>
                </a:extLst>
              </a:tr>
              <a:tr h="127782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/equine/</a:t>
                      </a:r>
                      <a:r>
                        <a:rPr lang="en-GB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ntainbleau</a:t>
                      </a:r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1/1979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032412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032411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032410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032405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032408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032407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032406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032409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35612556"/>
                  </a:ext>
                </a:extLst>
              </a:tr>
              <a:tr h="127782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/equine/Berlin/1/1989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032420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032419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032418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032413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032416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032415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032414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032417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34059110"/>
                  </a:ext>
                </a:extLst>
              </a:tr>
              <a:tr h="127782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/equine/Rook/93753/1989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032332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032331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032330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032325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032328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032327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032326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032329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17421236"/>
                  </a:ext>
                </a:extLst>
              </a:tr>
              <a:tr h="127782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/equine/Switzerland/173/1993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032364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032363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032362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032357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032360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032359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032358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032361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60106971"/>
                  </a:ext>
                </a:extLst>
              </a:tr>
              <a:tr h="127782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/equine/Newmarket/1/1993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J375218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J375230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J375226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N399025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J375214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J375222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J375234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J375210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05008738"/>
                  </a:ext>
                </a:extLst>
              </a:tr>
              <a:tr h="127782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/equine/Ohio/1/2003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Q124177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Q124172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Q124187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Q124192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Q124184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Q124168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Q124188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Q124186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9739829"/>
                  </a:ext>
                </a:extLst>
              </a:tr>
              <a:tr h="127782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/equine/Newmarket/5/2003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J375221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J375233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J375228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J375213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J375216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J375224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J375236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J375209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21954839"/>
                  </a:ext>
                </a:extLst>
              </a:tr>
              <a:tr h="127782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/equine/South_Africa/4/2003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N797667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N797668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N797669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N797670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N797671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N797672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N797673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N797674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35964616"/>
                  </a:ext>
                </a:extLst>
              </a:tr>
              <a:tr h="127782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/equine/Ohio/113461-1/2005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067315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067316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067317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067318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067319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067320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067321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067322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62637821"/>
                  </a:ext>
                </a:extLst>
              </a:tr>
              <a:tr h="127782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/equine/</a:t>
                      </a:r>
                      <a:r>
                        <a:rPr lang="en-GB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Jouars</a:t>
                      </a:r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4/2006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Y241366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Y241372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Y241378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JX091752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Y241321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Y241348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Y241354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Y241360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82179529"/>
                  </a:ext>
                </a:extLst>
              </a:tr>
              <a:tr h="127782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/equine/Xinjiang/1/2007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U794540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U794541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U794542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U794543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U794544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U794545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U794546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U794547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77052211"/>
                  </a:ext>
                </a:extLst>
              </a:tr>
              <a:tr h="127782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/equine/Richmond/1/2007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F559332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F559333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F559334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J195395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F559335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F559336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F559337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J195429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20878415"/>
                  </a:ext>
                </a:extLst>
              </a:tr>
              <a:tr h="127782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/equine/Lincolnshire/1/2007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F559338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F559339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F559340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J195398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F559341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F559342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F559343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J195427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84546496"/>
                  </a:ext>
                </a:extLst>
              </a:tr>
              <a:tr h="127782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/equine/Belfond/6-2/2009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Y241367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Y241373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Y241379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Y241314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Y272866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Y241350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Y241355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Y241361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10413853"/>
                  </a:ext>
                </a:extLst>
              </a:tr>
              <a:tr h="127782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/equine/Yokohama/aq13/2010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C369077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C369078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C369079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C369080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C369081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C369082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C369083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C369084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99134101"/>
                  </a:ext>
                </a:extLst>
              </a:tr>
              <a:tr h="127782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/equine/Neuville-Pres-Sees/1/2011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Y241368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Y241374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Y241380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Y241316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Y241322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Y241347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Y241359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Y241362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32736734"/>
                  </a:ext>
                </a:extLst>
              </a:tr>
              <a:tr h="127782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/equine/Florida/146609/2011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F173363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F173219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F173307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F173407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F173304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F173237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F173292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F173196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85672623"/>
                  </a:ext>
                </a:extLst>
              </a:tr>
              <a:tr h="127782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/equine/Xuzhou/01/2013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F806992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F806991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F806990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F806985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F806988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F806987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F806986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F806989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41048558"/>
                  </a:ext>
                </a:extLst>
              </a:tr>
              <a:tr h="127782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/equine/Gironde/1/2014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Y241370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Y241376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Y241382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Y241319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Y241324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Y241352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Y241357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Y241364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46923887"/>
                  </a:ext>
                </a:extLst>
              </a:tr>
              <a:tr h="127782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/equine/Saone-et-Loire/1/2015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Y241371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Y241377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Y241383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Y241320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Y241325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Y241353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Y241358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Y241365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98317331"/>
                  </a:ext>
                </a:extLst>
              </a:tr>
              <a:tr h="127782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/equine/Malaysia/1/2015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H135220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H135221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H135222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H135223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H135224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H135225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H135226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H135227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10995679"/>
                  </a:ext>
                </a:extLst>
              </a:tr>
              <a:tr h="127782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/</a:t>
                      </a:r>
                      <a:r>
                        <a:rPr lang="en-GB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quus_ferus_caballus</a:t>
                      </a:r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USA/51053/2019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212122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212123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212124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212125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212126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212127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212128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212129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31968083"/>
                  </a:ext>
                </a:extLst>
              </a:tr>
              <a:tr h="127782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/donkey/Nigeria/VRD19_ZM20_T10_19RS459-5/2019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272441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272440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272439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BlToT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272437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272436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272435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272438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51981180"/>
                  </a:ext>
                </a:extLst>
              </a:tr>
              <a:tr h="127782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/donkey/Senegal/44/2019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BlToT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BlToT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BlToT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272434</a:t>
                      </a: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BlToT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BlToT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BlToT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45" marR="5545" marT="5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BlToT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1919133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54470298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5176</TotalTime>
  <Words>417</Words>
  <Application>Microsoft Macintosh PowerPoint</Application>
  <PresentationFormat>A4 Paper (210x297 mm)</PresentationFormat>
  <Paragraphs>23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Sophie POLLET</dc:creator>
  <cp:lastModifiedBy>Lena Kleij</cp:lastModifiedBy>
  <cp:revision>236</cp:revision>
  <cp:lastPrinted>2023-10-09T13:57:45Z</cp:lastPrinted>
  <dcterms:created xsi:type="dcterms:W3CDTF">2023-02-16T15:54:12Z</dcterms:created>
  <dcterms:modified xsi:type="dcterms:W3CDTF">2023-10-24T12:36:14Z</dcterms:modified>
</cp:coreProperties>
</file>